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3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8%20&#26792;&#30456;&#20284;&#22522;&#22240;&#23547;&#25214;\PcMYB173&#65288;MYBPA1)\&#26792;&#21407;&#33457;&#38738;&#32032;&#32467;&#26500;&#22522;&#22240;\LAR,ANR&#22522;&#22240;&#34920;&#36798;&#373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8%20&#26792;&#30456;&#20284;&#22522;&#22240;&#23547;&#25214;\PcMYB173&#65288;MYBPA1)\&#26792;&#21407;&#33457;&#38738;&#32032;&#32467;&#26500;&#22522;&#22240;\LAR,ANR&#22522;&#22240;&#34920;&#36798;&#3732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8%20&#26792;&#30456;&#20284;&#22522;&#22240;&#23547;&#25214;\PcMYB173&#65288;MYBPA1)\&#26792;&#21407;&#33457;&#38738;&#32032;&#32467;&#26500;&#22522;&#22240;\LAR,ANR&#22522;&#22240;&#34920;&#36798;&#3732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55</c:f>
              <c:strCache>
                <c:ptCount val="1"/>
                <c:pt idx="0">
                  <c:v>Bet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60:$D$60</c:f>
                <c:numCache>
                  <c:formatCode>General</c:formatCode>
                  <c:ptCount val="2"/>
                  <c:pt idx="0">
                    <c:v>1.4268648329266556</c:v>
                  </c:pt>
                  <c:pt idx="1">
                    <c:v>0.528206609165321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54:$D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C$55:$D$55</c:f>
              <c:numCache>
                <c:formatCode>General</c:formatCode>
                <c:ptCount val="2"/>
                <c:pt idx="0">
                  <c:v>14.843120460124235</c:v>
                </c:pt>
                <c:pt idx="1">
                  <c:v>1.79610833167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A9-46C1-ABBB-DB171CFA89B6}"/>
            </c:ext>
          </c:extLst>
        </c:ser>
        <c:ser>
          <c:idx val="1"/>
          <c:order val="1"/>
          <c:tx>
            <c:strRef>
              <c:f>Sheet2!$B$56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rgbClr val="BB9FC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61:$D$61</c:f>
                <c:numCache>
                  <c:formatCode>General</c:formatCode>
                  <c:ptCount val="2"/>
                  <c:pt idx="0">
                    <c:v>4.0441302178206575</c:v>
                  </c:pt>
                  <c:pt idx="1">
                    <c:v>0.195535134684831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54:$D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C$56:$D$56</c:f>
              <c:numCache>
                <c:formatCode>General</c:formatCode>
                <c:ptCount val="2"/>
                <c:pt idx="0">
                  <c:v>41.771074203755866</c:v>
                </c:pt>
                <c:pt idx="1">
                  <c:v>0.8873086318609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A9-46C1-ABBB-DB171CFA89B6}"/>
            </c:ext>
          </c:extLst>
        </c:ser>
        <c:ser>
          <c:idx val="2"/>
          <c:order val="2"/>
          <c:tx>
            <c:strRef>
              <c:f>Sheet2!$B$57</c:f>
              <c:strCache>
                <c:ptCount val="1"/>
                <c:pt idx="0">
                  <c:v>HXS</c:v>
                </c:pt>
              </c:strCache>
            </c:strRef>
          </c:tx>
          <c:spPr>
            <a:solidFill>
              <a:srgbClr val="54823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62:$D$62</c:f>
                <c:numCache>
                  <c:formatCode>General</c:formatCode>
                  <c:ptCount val="2"/>
                  <c:pt idx="0">
                    <c:v>0.12758184994392277</c:v>
                  </c:pt>
                  <c:pt idx="1">
                    <c:v>8.345959826843081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54:$D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C$57:$D$57</c:f>
              <c:numCache>
                <c:formatCode>General</c:formatCode>
                <c:ptCount val="2"/>
                <c:pt idx="0">
                  <c:v>3.6292336825571998</c:v>
                </c:pt>
                <c:pt idx="1">
                  <c:v>0.31659924626153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0A9-46C1-ABBB-DB171CFA89B6}"/>
            </c:ext>
          </c:extLst>
        </c:ser>
        <c:ser>
          <c:idx val="3"/>
          <c:order val="3"/>
          <c:tx>
            <c:strRef>
              <c:f>Sheet2!$B$58</c:f>
              <c:strCache>
                <c:ptCount val="1"/>
                <c:pt idx="0">
                  <c:v>DSS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63:$D$63</c:f>
                <c:numCache>
                  <c:formatCode>General</c:formatCode>
                  <c:ptCount val="2"/>
                  <c:pt idx="0">
                    <c:v>0.83130467306754474</c:v>
                  </c:pt>
                  <c:pt idx="1">
                    <c:v>0.150726826895316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54:$D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C$58:$D$58</c:f>
              <c:numCache>
                <c:formatCode>General</c:formatCode>
                <c:ptCount val="2"/>
                <c:pt idx="0">
                  <c:v>4.6939590419963073</c:v>
                </c:pt>
                <c:pt idx="1">
                  <c:v>0.272823592966848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0A9-46C1-ABBB-DB171CFA89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3549600"/>
        <c:axId val="733550584"/>
      </c:barChart>
      <c:catAx>
        <c:axId val="733549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33550584"/>
        <c:crosses val="autoZero"/>
        <c:auto val="1"/>
        <c:lblAlgn val="ctr"/>
        <c:lblOffset val="100"/>
        <c:noMultiLvlLbl val="0"/>
      </c:catAx>
      <c:valAx>
        <c:axId val="733550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335496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6715480900276596"/>
          <c:y val="0.11423709881988194"/>
          <c:w val="0.35600494921458858"/>
          <c:h val="0.375445088756778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lang="en-US" altLang="zh-CN"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55</c:f>
              <c:strCache>
                <c:ptCount val="1"/>
                <c:pt idx="0">
                  <c:v>Bet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60:$I$60</c:f>
                <c:numCache>
                  <c:formatCode>General</c:formatCode>
                  <c:ptCount val="2"/>
                  <c:pt idx="0">
                    <c:v>0.21354094260914439</c:v>
                  </c:pt>
                  <c:pt idx="1">
                    <c:v>0.817001878155429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54:$I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H$55:$I$55</c:f>
              <c:numCache>
                <c:formatCode>General</c:formatCode>
                <c:ptCount val="2"/>
                <c:pt idx="0">
                  <c:v>1.8587955375829199</c:v>
                </c:pt>
                <c:pt idx="1">
                  <c:v>16.1203240600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08-42E6-9E58-9884C90D525C}"/>
            </c:ext>
          </c:extLst>
        </c:ser>
        <c:ser>
          <c:idx val="1"/>
          <c:order val="1"/>
          <c:tx>
            <c:strRef>
              <c:f>Sheet2!$G$56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rgbClr val="BB9FC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61:$I$61</c:f>
                <c:numCache>
                  <c:formatCode>General</c:formatCode>
                  <c:ptCount val="2"/>
                  <c:pt idx="0">
                    <c:v>0.25603769690166533</c:v>
                  </c:pt>
                  <c:pt idx="1">
                    <c:v>0.470651573109781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54:$I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H$56:$I$56</c:f>
              <c:numCache>
                <c:formatCode>General</c:formatCode>
                <c:ptCount val="2"/>
                <c:pt idx="0">
                  <c:v>8.8406754498761995</c:v>
                </c:pt>
                <c:pt idx="1">
                  <c:v>17.385970755040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08-42E6-9E58-9884C90D525C}"/>
            </c:ext>
          </c:extLst>
        </c:ser>
        <c:ser>
          <c:idx val="2"/>
          <c:order val="2"/>
          <c:tx>
            <c:strRef>
              <c:f>Sheet2!$G$57</c:f>
              <c:strCache>
                <c:ptCount val="1"/>
                <c:pt idx="0">
                  <c:v>HXS</c:v>
                </c:pt>
              </c:strCache>
            </c:strRef>
          </c:tx>
          <c:spPr>
            <a:solidFill>
              <a:srgbClr val="54823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62:$I$62</c:f>
                <c:numCache>
                  <c:formatCode>General</c:formatCode>
                  <c:ptCount val="2"/>
                  <c:pt idx="0">
                    <c:v>0.24408936139408952</c:v>
                  </c:pt>
                  <c:pt idx="1">
                    <c:v>0.964263524000214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54:$I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H$57:$I$57</c:f>
              <c:numCache>
                <c:formatCode>General</c:formatCode>
                <c:ptCount val="2"/>
                <c:pt idx="0">
                  <c:v>3.11784825044478</c:v>
                </c:pt>
                <c:pt idx="1">
                  <c:v>11.174399885262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308-42E6-9E58-9884C90D525C}"/>
            </c:ext>
          </c:extLst>
        </c:ser>
        <c:ser>
          <c:idx val="3"/>
          <c:order val="3"/>
          <c:tx>
            <c:strRef>
              <c:f>Sheet2!$G$58</c:f>
              <c:strCache>
                <c:ptCount val="1"/>
                <c:pt idx="0">
                  <c:v>DSS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63:$I$63</c:f>
                <c:numCache>
                  <c:formatCode>General</c:formatCode>
                  <c:ptCount val="2"/>
                  <c:pt idx="0">
                    <c:v>0.16725237773276572</c:v>
                  </c:pt>
                  <c:pt idx="1">
                    <c:v>0.448638401716532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54:$I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H$58:$I$58</c:f>
              <c:numCache>
                <c:formatCode>General</c:formatCode>
                <c:ptCount val="2"/>
                <c:pt idx="0">
                  <c:v>1.9156246376469701</c:v>
                </c:pt>
                <c:pt idx="1">
                  <c:v>10.659110015773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308-42E6-9E58-9884C90D52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5117192"/>
        <c:axId val="645112600"/>
      </c:barChart>
      <c:catAx>
        <c:axId val="645117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5112600"/>
        <c:crosses val="autoZero"/>
        <c:auto val="1"/>
        <c:lblAlgn val="ctr"/>
        <c:lblOffset val="100"/>
        <c:noMultiLvlLbl val="0"/>
      </c:catAx>
      <c:valAx>
        <c:axId val="645112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511719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677611049984081"/>
          <c:y val="0.11423639977226734"/>
          <c:w val="0.33222573667813743"/>
          <c:h val="0.31730544063695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lang="en-US" altLang="zh-CN"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55</c:f>
              <c:strCache>
                <c:ptCount val="1"/>
                <c:pt idx="0">
                  <c:v>Bet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60:$N$60</c:f>
                <c:numCache>
                  <c:formatCode>General</c:formatCode>
                  <c:ptCount val="2"/>
                  <c:pt idx="0">
                    <c:v>0.12657438180181552</c:v>
                  </c:pt>
                  <c:pt idx="1">
                    <c:v>0.246979447203703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54:$N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M$55:$N$55</c:f>
              <c:numCache>
                <c:formatCode>General</c:formatCode>
                <c:ptCount val="2"/>
                <c:pt idx="0">
                  <c:v>1.6692457973672068</c:v>
                </c:pt>
                <c:pt idx="1">
                  <c:v>10.193316495120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99-4FB5-98C9-8F2CA4C8E1D7}"/>
            </c:ext>
          </c:extLst>
        </c:ser>
        <c:ser>
          <c:idx val="1"/>
          <c:order val="1"/>
          <c:tx>
            <c:strRef>
              <c:f>Sheet2!$L$56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rgbClr val="BB9FC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61:$N$61</c:f>
                <c:numCache>
                  <c:formatCode>General</c:formatCode>
                  <c:ptCount val="2"/>
                  <c:pt idx="0">
                    <c:v>1.1961422008614286</c:v>
                  </c:pt>
                  <c:pt idx="1">
                    <c:v>1.24535188950389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54:$N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M$56:$N$56</c:f>
              <c:numCache>
                <c:formatCode>General</c:formatCode>
                <c:ptCount val="2"/>
                <c:pt idx="0">
                  <c:v>9.9491828713555677</c:v>
                </c:pt>
                <c:pt idx="1">
                  <c:v>12.232724047187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99-4FB5-98C9-8F2CA4C8E1D7}"/>
            </c:ext>
          </c:extLst>
        </c:ser>
        <c:ser>
          <c:idx val="2"/>
          <c:order val="2"/>
          <c:tx>
            <c:strRef>
              <c:f>Sheet2!$L$57</c:f>
              <c:strCache>
                <c:ptCount val="1"/>
                <c:pt idx="0">
                  <c:v>HXS</c:v>
                </c:pt>
              </c:strCache>
            </c:strRef>
          </c:tx>
          <c:spPr>
            <a:solidFill>
              <a:srgbClr val="54823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62:$N$62</c:f>
                <c:numCache>
                  <c:formatCode>General</c:formatCode>
                  <c:ptCount val="2"/>
                  <c:pt idx="0">
                    <c:v>9.1797625804114852E-2</c:v>
                  </c:pt>
                  <c:pt idx="1">
                    <c:v>7.813307864664847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54:$N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M$57:$N$57</c:f>
              <c:numCache>
                <c:formatCode>General</c:formatCode>
                <c:ptCount val="2"/>
                <c:pt idx="0">
                  <c:v>0.13117868778653061</c:v>
                </c:pt>
                <c:pt idx="1">
                  <c:v>1.4666894495216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99-4FB5-98C9-8F2CA4C8E1D7}"/>
            </c:ext>
          </c:extLst>
        </c:ser>
        <c:ser>
          <c:idx val="3"/>
          <c:order val="3"/>
          <c:tx>
            <c:strRef>
              <c:f>Sheet2!$L$58</c:f>
              <c:strCache>
                <c:ptCount val="1"/>
                <c:pt idx="0">
                  <c:v>DSS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63:$N$63</c:f>
                <c:numCache>
                  <c:formatCode>General</c:formatCode>
                  <c:ptCount val="2"/>
                  <c:pt idx="0">
                    <c:v>9.8835438576646881E-2</c:v>
                  </c:pt>
                  <c:pt idx="1">
                    <c:v>0.574869369974719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54:$N$54</c:f>
              <c:strCache>
                <c:ptCount val="2"/>
                <c:pt idx="0">
                  <c:v>30DAFB</c:v>
                </c:pt>
                <c:pt idx="1">
                  <c:v>120DAFB</c:v>
                </c:pt>
              </c:strCache>
            </c:strRef>
          </c:cat>
          <c:val>
            <c:numRef>
              <c:f>Sheet2!$M$58:$N$58</c:f>
              <c:numCache>
                <c:formatCode>General</c:formatCode>
                <c:ptCount val="2"/>
                <c:pt idx="0">
                  <c:v>0.22137144274783602</c:v>
                </c:pt>
                <c:pt idx="1">
                  <c:v>4.11580245724909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899-4FB5-98C9-8F2CA4C8E1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0038072"/>
        <c:axId val="730038728"/>
      </c:barChart>
      <c:catAx>
        <c:axId val="730038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30038728"/>
        <c:crosses val="autoZero"/>
        <c:auto val="1"/>
        <c:lblAlgn val="ctr"/>
        <c:lblOffset val="100"/>
        <c:noMultiLvlLbl val="0"/>
      </c:catAx>
      <c:valAx>
        <c:axId val="730038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3003807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0291873709961015"/>
          <c:y val="8.9239964572101121E-2"/>
          <c:w val="0.36310068037611809"/>
          <c:h val="0.294239300794353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lang="en-US" altLang="zh-CN"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0F91B9-AE16-4203-B7D3-5503D3F8788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7326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3" Type="http://schemas.openxmlformats.org/officeDocument/2006/relationships/chart" Target="../charts/chart1.xml"/><Relationship Id="rId7" Type="http://schemas.openxmlformats.org/officeDocument/2006/relationships/image" Target="../media/image2.png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openxmlformats.org/officeDocument/2006/relationships/image" Target="../media/image6.png"/><Relationship Id="rId5" Type="http://schemas.openxmlformats.org/officeDocument/2006/relationships/chart" Target="../charts/chart3.xml"/><Relationship Id="rId10" Type="http://schemas.openxmlformats.org/officeDocument/2006/relationships/image" Target="../media/image5.png"/><Relationship Id="rId4" Type="http://schemas.openxmlformats.org/officeDocument/2006/relationships/chart" Target="../charts/chart2.xml"/><Relationship Id="rId9" Type="http://schemas.openxmlformats.org/officeDocument/2006/relationships/image" Target="../media/image4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>
            <a:extLst>
              <a:ext uri="{FF2B5EF4-FFF2-40B4-BE49-F238E27FC236}">
                <a16:creationId xmlns:a16="http://schemas.microsoft.com/office/drawing/2014/main" id="{56B34E16-CA70-41C3-84E0-55978AA2674D}"/>
              </a:ext>
            </a:extLst>
          </p:cNvPr>
          <p:cNvSpPr txBox="1"/>
          <p:nvPr/>
        </p:nvSpPr>
        <p:spPr>
          <a:xfrm>
            <a:off x="6748374" y="3479311"/>
            <a:ext cx="12341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R(Pspp.Chr13.00394)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F9A12AE-0FB7-41E7-8D5C-D696426246EF}"/>
              </a:ext>
            </a:extLst>
          </p:cNvPr>
          <p:cNvSpPr txBox="1"/>
          <p:nvPr/>
        </p:nvSpPr>
        <p:spPr>
          <a:xfrm rot="16200000">
            <a:off x="6311246" y="4122489"/>
            <a:ext cx="516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KM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5C2CFEB-6409-43D1-BB65-3CB13B957123}"/>
              </a:ext>
            </a:extLst>
          </p:cNvPr>
          <p:cNvSpPr txBox="1"/>
          <p:nvPr/>
        </p:nvSpPr>
        <p:spPr>
          <a:xfrm>
            <a:off x="8450176" y="3479311"/>
            <a:ext cx="154213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R1(Pspp.Chr05.02768)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BABCC82-2F59-42A4-BD2D-DCD07D223E0F}"/>
              </a:ext>
            </a:extLst>
          </p:cNvPr>
          <p:cNvSpPr txBox="1"/>
          <p:nvPr/>
        </p:nvSpPr>
        <p:spPr>
          <a:xfrm rot="16200000">
            <a:off x="7990352" y="4122488"/>
            <a:ext cx="516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KM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B975D1D-50C5-43A8-9858-0DF44788C796}"/>
              </a:ext>
            </a:extLst>
          </p:cNvPr>
          <p:cNvSpPr txBox="1"/>
          <p:nvPr/>
        </p:nvSpPr>
        <p:spPr>
          <a:xfrm>
            <a:off x="10186048" y="3441693"/>
            <a:ext cx="125730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R2(Pspp.Chr10.02574)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3C1FA1F-B192-496A-A76E-D90BA371A3F6}"/>
              </a:ext>
            </a:extLst>
          </p:cNvPr>
          <p:cNvSpPr txBox="1"/>
          <p:nvPr/>
        </p:nvSpPr>
        <p:spPr>
          <a:xfrm rot="16200000">
            <a:off x="9770548" y="4099851"/>
            <a:ext cx="516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KM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6C9C99C-2BFD-40DC-8089-BD7F79682352}"/>
              </a:ext>
            </a:extLst>
          </p:cNvPr>
          <p:cNvSpPr txBox="1"/>
          <p:nvPr/>
        </p:nvSpPr>
        <p:spPr>
          <a:xfrm>
            <a:off x="957305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6584F92-A9FA-434A-AB7D-A609D8501FFC}"/>
              </a:ext>
            </a:extLst>
          </p:cNvPr>
          <p:cNvSpPr txBox="1"/>
          <p:nvPr/>
        </p:nvSpPr>
        <p:spPr>
          <a:xfrm>
            <a:off x="957305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02C31C0C-F97D-4513-B9A8-00616CC66D73}"/>
              </a:ext>
            </a:extLst>
          </p:cNvPr>
          <p:cNvSpPr txBox="1"/>
          <p:nvPr/>
        </p:nvSpPr>
        <p:spPr>
          <a:xfrm>
            <a:off x="6435689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4C86549-41C0-4B69-9CCD-59367FA1465C}"/>
              </a:ext>
            </a:extLst>
          </p:cNvPr>
          <p:cNvSpPr txBox="1"/>
          <p:nvPr/>
        </p:nvSpPr>
        <p:spPr>
          <a:xfrm>
            <a:off x="8116513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8DB0B99-A424-4523-BA9A-3B45F9FB0E9A}"/>
              </a:ext>
            </a:extLst>
          </p:cNvPr>
          <p:cNvSpPr txBox="1"/>
          <p:nvPr/>
        </p:nvSpPr>
        <p:spPr>
          <a:xfrm>
            <a:off x="9861538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9" name="图表 48">
            <a:extLst>
              <a:ext uri="{FF2B5EF4-FFF2-40B4-BE49-F238E27FC236}">
                <a16:creationId xmlns:a16="http://schemas.microsoft.com/office/drawing/2014/main" id="{FC30859C-3BED-4924-B722-2F1A64CB98F5}"/>
              </a:ext>
            </a:extLst>
          </p:cNvPr>
          <p:cNvGraphicFramePr>
            <a:graphicFrameLocks/>
          </p:cNvGraphicFramePr>
          <p:nvPr/>
        </p:nvGraphicFramePr>
        <p:xfrm>
          <a:off x="6535063" y="3441693"/>
          <a:ext cx="1465282" cy="2094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1" name="图表 50">
            <a:extLst>
              <a:ext uri="{FF2B5EF4-FFF2-40B4-BE49-F238E27FC236}">
                <a16:creationId xmlns:a16="http://schemas.microsoft.com/office/drawing/2014/main" id="{B84983C1-7501-49A4-B1F4-4C82C36FAD5A}"/>
              </a:ext>
            </a:extLst>
          </p:cNvPr>
          <p:cNvGraphicFramePr>
            <a:graphicFrameLocks/>
          </p:cNvGraphicFramePr>
          <p:nvPr/>
        </p:nvGraphicFramePr>
        <p:xfrm>
          <a:off x="8222469" y="3479311"/>
          <a:ext cx="1595948" cy="2056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2" name="图表 51">
            <a:extLst>
              <a:ext uri="{FF2B5EF4-FFF2-40B4-BE49-F238E27FC236}">
                <a16:creationId xmlns:a16="http://schemas.microsoft.com/office/drawing/2014/main" id="{871ABE41-151E-4D31-96A6-8D0B2708FC55}"/>
              </a:ext>
            </a:extLst>
          </p:cNvPr>
          <p:cNvGraphicFramePr>
            <a:graphicFrameLocks/>
          </p:cNvGraphicFramePr>
          <p:nvPr/>
        </p:nvGraphicFramePr>
        <p:xfrm>
          <a:off x="9979915" y="3479310"/>
          <a:ext cx="1542134" cy="2056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3" name="组合 12">
            <a:extLst>
              <a:ext uri="{FF2B5EF4-FFF2-40B4-BE49-F238E27FC236}">
                <a16:creationId xmlns:a16="http://schemas.microsoft.com/office/drawing/2014/main" id="{AF09259C-2A2A-4D61-81A3-D4174DC8E462}"/>
              </a:ext>
            </a:extLst>
          </p:cNvPr>
          <p:cNvGrpSpPr/>
          <p:nvPr/>
        </p:nvGrpSpPr>
        <p:grpSpPr>
          <a:xfrm>
            <a:off x="3032708" y="1367767"/>
            <a:ext cx="1729980" cy="1877619"/>
            <a:chOff x="3032708" y="1367767"/>
            <a:chExt cx="1729980" cy="1877619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3899A64D-767E-4839-9EC6-6B576C6CAFD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32708" y="1515406"/>
              <a:ext cx="1729980" cy="172998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99C3C78-EE73-45AA-8F4A-BA914271855E}"/>
                </a:ext>
              </a:extLst>
            </p:cNvPr>
            <p:cNvSpPr txBox="1"/>
            <p:nvPr/>
          </p:nvSpPr>
          <p:spPr>
            <a:xfrm>
              <a:off x="3273383" y="1367767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_30dvsHXS_3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0225F74E-B01E-418D-97E3-8E66FE40AC2A}"/>
              </a:ext>
            </a:extLst>
          </p:cNvPr>
          <p:cNvGrpSpPr/>
          <p:nvPr/>
        </p:nvGrpSpPr>
        <p:grpSpPr>
          <a:xfrm>
            <a:off x="4759044" y="1367785"/>
            <a:ext cx="1732280" cy="1879901"/>
            <a:chOff x="4759044" y="1367785"/>
            <a:chExt cx="1732280" cy="1879901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7A7BD4F6-A7A2-4A2D-94C8-32B2E11C3AC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9044" y="1515406"/>
              <a:ext cx="1732280" cy="1732280"/>
            </a:xfrm>
            <a:prstGeom prst="rect">
              <a:avLst/>
            </a:prstGeom>
          </p:spPr>
        </p:pic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177B84DE-18DB-47DB-82A2-83F99468B27E}"/>
                </a:ext>
              </a:extLst>
            </p:cNvPr>
            <p:cNvSpPr txBox="1"/>
            <p:nvPr/>
          </p:nvSpPr>
          <p:spPr>
            <a:xfrm>
              <a:off x="4995498" y="1367785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_30dvsDSS_3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4B16562F-A7BA-4727-8E48-798756EC3298}"/>
              </a:ext>
            </a:extLst>
          </p:cNvPr>
          <p:cNvGrpSpPr/>
          <p:nvPr/>
        </p:nvGrpSpPr>
        <p:grpSpPr>
          <a:xfrm>
            <a:off x="8216958" y="1367145"/>
            <a:ext cx="1732280" cy="1878591"/>
            <a:chOff x="8216958" y="1367145"/>
            <a:chExt cx="1732280" cy="1878591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B3B8821-A58A-4974-8A9F-ABBB0E58FD1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6958" y="1513456"/>
              <a:ext cx="1732280" cy="1732280"/>
            </a:xfrm>
            <a:prstGeom prst="rect">
              <a:avLst/>
            </a:prstGeom>
          </p:spPr>
        </p:pic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D2A7ECD0-B864-453E-9CEC-302D84E9E98B}"/>
                </a:ext>
              </a:extLst>
            </p:cNvPr>
            <p:cNvSpPr txBox="1"/>
            <p:nvPr/>
          </p:nvSpPr>
          <p:spPr>
            <a:xfrm>
              <a:off x="8437477" y="1367145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_30dvsDSS_3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87C4854D-C53F-4671-AB53-6A670BDEDE2B}"/>
              </a:ext>
            </a:extLst>
          </p:cNvPr>
          <p:cNvGrpSpPr/>
          <p:nvPr/>
        </p:nvGrpSpPr>
        <p:grpSpPr>
          <a:xfrm>
            <a:off x="6499310" y="1363759"/>
            <a:ext cx="1732280" cy="1881977"/>
            <a:chOff x="6499310" y="1363759"/>
            <a:chExt cx="1732280" cy="1881977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9813BD5-BA9F-4788-AB51-8AB5B5473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9310" y="1513456"/>
              <a:ext cx="1732280" cy="1732280"/>
            </a:xfrm>
            <a:prstGeom prst="rect">
              <a:avLst/>
            </a:prstGeom>
          </p:spPr>
        </p:pic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1D6EB802-0DC7-469F-BF6E-AA0494D0DC48}"/>
                </a:ext>
              </a:extLst>
            </p:cNvPr>
            <p:cNvSpPr txBox="1"/>
            <p:nvPr/>
          </p:nvSpPr>
          <p:spPr>
            <a:xfrm>
              <a:off x="6729142" y="1363759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_30dvsHXS_3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14C013A6-8C65-4DF1-90E6-EF4BAAD7DF8C}"/>
              </a:ext>
            </a:extLst>
          </p:cNvPr>
          <p:cNvGrpSpPr/>
          <p:nvPr/>
        </p:nvGrpSpPr>
        <p:grpSpPr>
          <a:xfrm>
            <a:off x="9948558" y="1360755"/>
            <a:ext cx="1732280" cy="1884631"/>
            <a:chOff x="9948558" y="1360755"/>
            <a:chExt cx="1732280" cy="1884631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49858440-15F2-416C-9D5D-F976E77004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48558" y="1513106"/>
              <a:ext cx="1732280" cy="1732280"/>
            </a:xfrm>
            <a:prstGeom prst="rect">
              <a:avLst/>
            </a:prstGeom>
          </p:spPr>
        </p:pic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73E2B83-D169-4280-A96D-345D6FBB146C}"/>
                </a:ext>
              </a:extLst>
            </p:cNvPr>
            <p:cNvSpPr txBox="1"/>
            <p:nvPr/>
          </p:nvSpPr>
          <p:spPr>
            <a:xfrm>
              <a:off x="10089240" y="1360755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_120dvsHXS_12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8F22A1D5-D399-4EF0-BB2B-0E7B7EECE386}"/>
              </a:ext>
            </a:extLst>
          </p:cNvPr>
          <p:cNvGrpSpPr/>
          <p:nvPr/>
        </p:nvGrpSpPr>
        <p:grpSpPr>
          <a:xfrm>
            <a:off x="1321377" y="3279427"/>
            <a:ext cx="1732280" cy="1880647"/>
            <a:chOff x="1321377" y="3279427"/>
            <a:chExt cx="1732280" cy="1880647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18B60A0D-98F7-44D8-9BE4-E178515B590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1377" y="3427794"/>
              <a:ext cx="1732280" cy="1732280"/>
            </a:xfrm>
            <a:prstGeom prst="rect">
              <a:avLst/>
            </a:prstGeom>
          </p:spPr>
        </p:pic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0CD47EE6-B061-4BA8-BF19-533F7C1527B2}"/>
                </a:ext>
              </a:extLst>
            </p:cNvPr>
            <p:cNvSpPr txBox="1"/>
            <p:nvPr/>
          </p:nvSpPr>
          <p:spPr>
            <a:xfrm>
              <a:off x="1457837" y="3279427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_120dvsDSS_12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62AC42AD-D4C9-4282-A656-FAE339E7AF53}"/>
              </a:ext>
            </a:extLst>
          </p:cNvPr>
          <p:cNvGrpSpPr/>
          <p:nvPr/>
        </p:nvGrpSpPr>
        <p:grpSpPr>
          <a:xfrm>
            <a:off x="3059343" y="3274940"/>
            <a:ext cx="1732280" cy="1880634"/>
            <a:chOff x="3059343" y="3274940"/>
            <a:chExt cx="1732280" cy="1880634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B252F61B-BB01-4AF3-B9A4-EFAA7F3DC6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9343" y="3423294"/>
              <a:ext cx="1732280" cy="1732280"/>
            </a:xfrm>
            <a:prstGeom prst="rect">
              <a:avLst/>
            </a:prstGeom>
          </p:spPr>
        </p:pic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6A6628BA-5128-43BD-999E-4532291D22D2}"/>
                </a:ext>
              </a:extLst>
            </p:cNvPr>
            <p:cNvSpPr txBox="1"/>
            <p:nvPr/>
          </p:nvSpPr>
          <p:spPr>
            <a:xfrm>
              <a:off x="3203889" y="3274940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_120dvsHXS_12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C880985F-BBB8-4529-A8DF-08EAF355A06A}"/>
              </a:ext>
            </a:extLst>
          </p:cNvPr>
          <p:cNvGrpSpPr/>
          <p:nvPr/>
        </p:nvGrpSpPr>
        <p:grpSpPr>
          <a:xfrm>
            <a:off x="4782204" y="3277340"/>
            <a:ext cx="1732280" cy="1880534"/>
            <a:chOff x="4782204" y="3277340"/>
            <a:chExt cx="1732280" cy="1880534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7EC3268C-DB72-491F-A235-5B0BF3DAE8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82204" y="3425594"/>
              <a:ext cx="1732280" cy="1732280"/>
            </a:xfrm>
            <a:prstGeom prst="rect">
              <a:avLst/>
            </a:prstGeom>
          </p:spPr>
        </p:pic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36436E4D-8D32-4FEE-A28E-2A8BFAC338D6}"/>
                </a:ext>
              </a:extLst>
            </p:cNvPr>
            <p:cNvSpPr txBox="1"/>
            <p:nvPr/>
          </p:nvSpPr>
          <p:spPr>
            <a:xfrm>
              <a:off x="4930208" y="3277340"/>
              <a:ext cx="126279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_120dvsDSS_120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A3A5CA42-C24F-4C78-9677-9D660D3B7263}"/>
              </a:ext>
            </a:extLst>
          </p:cNvPr>
          <p:cNvSpPr txBox="1"/>
          <p:nvPr/>
        </p:nvSpPr>
        <p:spPr>
          <a:xfrm>
            <a:off x="2949478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3D12771-4193-42EB-B50A-F05821E86A6D}"/>
              </a:ext>
            </a:extLst>
          </p:cNvPr>
          <p:cNvSpPr txBox="1"/>
          <p:nvPr/>
        </p:nvSpPr>
        <p:spPr>
          <a:xfrm>
            <a:off x="4689744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D97D35A-9BCB-4C25-8C99-FEB058229DA3}"/>
              </a:ext>
            </a:extLst>
          </p:cNvPr>
          <p:cNvSpPr txBox="1"/>
          <p:nvPr/>
        </p:nvSpPr>
        <p:spPr>
          <a:xfrm>
            <a:off x="6397967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1C65B06-A163-4AFF-8A5F-BFD5237A16DB}"/>
              </a:ext>
            </a:extLst>
          </p:cNvPr>
          <p:cNvSpPr txBox="1"/>
          <p:nvPr/>
        </p:nvSpPr>
        <p:spPr>
          <a:xfrm>
            <a:off x="8057727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23A1A5F-CAB2-4AF7-B7B8-DE51F7017DE0}"/>
              </a:ext>
            </a:extLst>
          </p:cNvPr>
          <p:cNvSpPr txBox="1"/>
          <p:nvPr/>
        </p:nvSpPr>
        <p:spPr>
          <a:xfrm>
            <a:off x="9833263" y="1374657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902453A-2DD9-4EBA-8349-C99D735E7B98}"/>
              </a:ext>
            </a:extLst>
          </p:cNvPr>
          <p:cNvSpPr txBox="1"/>
          <p:nvPr/>
        </p:nvSpPr>
        <p:spPr>
          <a:xfrm>
            <a:off x="2948103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AEF143E-AD22-43EE-9F5B-F11A86D62182}"/>
              </a:ext>
            </a:extLst>
          </p:cNvPr>
          <p:cNvSpPr txBox="1"/>
          <p:nvPr/>
        </p:nvSpPr>
        <p:spPr>
          <a:xfrm>
            <a:off x="4689744" y="3340811"/>
            <a:ext cx="5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A793D82F-4230-4BDB-A3CB-A55E44608A8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531" y="1421604"/>
            <a:ext cx="1759534" cy="1759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0893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4</Words>
  <Application>Microsoft Office PowerPoint</Application>
  <PresentationFormat>宽屏</PresentationFormat>
  <Paragraphs>2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7</cp:revision>
  <dcterms:created xsi:type="dcterms:W3CDTF">2025-04-18T01:16:52Z</dcterms:created>
  <dcterms:modified xsi:type="dcterms:W3CDTF">2025-04-18T01:29:59Z</dcterms:modified>
</cp:coreProperties>
</file>